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7" r:id="rId2"/>
  </p:sldIdLst>
  <p:sldSz cx="310896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5" d="100"/>
          <a:sy n="35" d="100"/>
        </p:scale>
        <p:origin x="1386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331720" y="3591562"/>
            <a:ext cx="26426160" cy="7640320"/>
          </a:xfrm>
        </p:spPr>
        <p:txBody>
          <a:bodyPr anchor="b"/>
          <a:lstStyle>
            <a:lvl1pPr algn="ctr">
              <a:defRPr sz="19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86200" y="11526522"/>
            <a:ext cx="23317200" cy="5298438"/>
          </a:xfrm>
        </p:spPr>
        <p:txBody>
          <a:bodyPr/>
          <a:lstStyle>
            <a:lvl1pPr marL="0" indent="0" algn="ctr">
              <a:buNone/>
              <a:defRPr sz="7680"/>
            </a:lvl1pPr>
            <a:lvl2pPr marL="1463040" indent="0" algn="ctr">
              <a:buNone/>
              <a:defRPr sz="6400"/>
            </a:lvl2pPr>
            <a:lvl3pPr marL="2926080" indent="0" algn="ctr">
              <a:buNone/>
              <a:defRPr sz="5760"/>
            </a:lvl3pPr>
            <a:lvl4pPr marL="4389120" indent="0" algn="ctr">
              <a:buNone/>
              <a:defRPr sz="5120"/>
            </a:lvl4pPr>
            <a:lvl5pPr marL="5852160" indent="0" algn="ctr">
              <a:buNone/>
              <a:defRPr sz="5120"/>
            </a:lvl5pPr>
            <a:lvl6pPr marL="7315200" indent="0" algn="ctr">
              <a:buNone/>
              <a:defRPr sz="5120"/>
            </a:lvl6pPr>
            <a:lvl7pPr marL="8778240" indent="0" algn="ctr">
              <a:buNone/>
              <a:defRPr sz="5120"/>
            </a:lvl7pPr>
            <a:lvl8pPr marL="10241280" indent="0" algn="ctr">
              <a:buNone/>
              <a:defRPr sz="5120"/>
            </a:lvl8pPr>
            <a:lvl9pPr marL="11704320" indent="0" algn="ctr">
              <a:buNone/>
              <a:defRPr sz="5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950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729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248497" y="1168400"/>
            <a:ext cx="6703695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37412" y="1168400"/>
            <a:ext cx="19722465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005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895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21219" y="5471167"/>
            <a:ext cx="26814780" cy="9128758"/>
          </a:xfrm>
        </p:spPr>
        <p:txBody>
          <a:bodyPr anchor="b"/>
          <a:lstStyle>
            <a:lvl1pPr>
              <a:defRPr sz="19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21219" y="14686287"/>
            <a:ext cx="26814780" cy="4800598"/>
          </a:xfrm>
        </p:spPr>
        <p:txBody>
          <a:bodyPr/>
          <a:lstStyle>
            <a:lvl1pPr marL="0" indent="0">
              <a:buNone/>
              <a:defRPr sz="7680">
                <a:solidFill>
                  <a:schemeClr val="tx1"/>
                </a:solidFill>
              </a:defRPr>
            </a:lvl1pPr>
            <a:lvl2pPr marL="146304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2pPr>
            <a:lvl3pPr marL="2926080" indent="0">
              <a:buNone/>
              <a:defRPr sz="5760">
                <a:solidFill>
                  <a:schemeClr val="tx1">
                    <a:tint val="75000"/>
                  </a:schemeClr>
                </a:solidFill>
              </a:defRPr>
            </a:lvl3pPr>
            <a:lvl4pPr marL="438912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4pPr>
            <a:lvl5pPr marL="585216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5pPr>
            <a:lvl6pPr marL="731520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6pPr>
            <a:lvl7pPr marL="877824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7pPr>
            <a:lvl8pPr marL="1024128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8pPr>
            <a:lvl9pPr marL="1170432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199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37410" y="5842000"/>
            <a:ext cx="1321308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39110" y="5842000"/>
            <a:ext cx="1321308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611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459" y="1168405"/>
            <a:ext cx="26814780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41463" y="5379722"/>
            <a:ext cx="13152356" cy="2636518"/>
          </a:xfrm>
        </p:spPr>
        <p:txBody>
          <a:bodyPr anchor="b"/>
          <a:lstStyle>
            <a:lvl1pPr marL="0" indent="0">
              <a:buNone/>
              <a:defRPr sz="7680" b="1"/>
            </a:lvl1pPr>
            <a:lvl2pPr marL="1463040" indent="0">
              <a:buNone/>
              <a:defRPr sz="6400" b="1"/>
            </a:lvl2pPr>
            <a:lvl3pPr marL="2926080" indent="0">
              <a:buNone/>
              <a:defRPr sz="5760" b="1"/>
            </a:lvl3pPr>
            <a:lvl4pPr marL="4389120" indent="0">
              <a:buNone/>
              <a:defRPr sz="5120" b="1"/>
            </a:lvl4pPr>
            <a:lvl5pPr marL="5852160" indent="0">
              <a:buNone/>
              <a:defRPr sz="5120" b="1"/>
            </a:lvl5pPr>
            <a:lvl6pPr marL="7315200" indent="0">
              <a:buNone/>
              <a:defRPr sz="5120" b="1"/>
            </a:lvl6pPr>
            <a:lvl7pPr marL="8778240" indent="0">
              <a:buNone/>
              <a:defRPr sz="5120" b="1"/>
            </a:lvl7pPr>
            <a:lvl8pPr marL="10241280" indent="0">
              <a:buNone/>
              <a:defRPr sz="5120" b="1"/>
            </a:lvl8pPr>
            <a:lvl9pPr marL="11704320" indent="0">
              <a:buNone/>
              <a:defRPr sz="5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41463" y="8016240"/>
            <a:ext cx="13152356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739112" y="5379722"/>
            <a:ext cx="13217129" cy="2636518"/>
          </a:xfrm>
        </p:spPr>
        <p:txBody>
          <a:bodyPr anchor="b"/>
          <a:lstStyle>
            <a:lvl1pPr marL="0" indent="0">
              <a:buNone/>
              <a:defRPr sz="7680" b="1"/>
            </a:lvl1pPr>
            <a:lvl2pPr marL="1463040" indent="0">
              <a:buNone/>
              <a:defRPr sz="6400" b="1"/>
            </a:lvl2pPr>
            <a:lvl3pPr marL="2926080" indent="0">
              <a:buNone/>
              <a:defRPr sz="5760" b="1"/>
            </a:lvl3pPr>
            <a:lvl4pPr marL="4389120" indent="0">
              <a:buNone/>
              <a:defRPr sz="5120" b="1"/>
            </a:lvl4pPr>
            <a:lvl5pPr marL="5852160" indent="0">
              <a:buNone/>
              <a:defRPr sz="5120" b="1"/>
            </a:lvl5pPr>
            <a:lvl6pPr marL="7315200" indent="0">
              <a:buNone/>
              <a:defRPr sz="5120" b="1"/>
            </a:lvl6pPr>
            <a:lvl7pPr marL="8778240" indent="0">
              <a:buNone/>
              <a:defRPr sz="5120" b="1"/>
            </a:lvl7pPr>
            <a:lvl8pPr marL="10241280" indent="0">
              <a:buNone/>
              <a:defRPr sz="5120" b="1"/>
            </a:lvl8pPr>
            <a:lvl9pPr marL="11704320" indent="0">
              <a:buNone/>
              <a:defRPr sz="5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739112" y="8016240"/>
            <a:ext cx="1321712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027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330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657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460" y="1463040"/>
            <a:ext cx="10027205" cy="5120640"/>
          </a:xfrm>
        </p:spPr>
        <p:txBody>
          <a:bodyPr anchor="b"/>
          <a:lstStyle>
            <a:lvl1pPr>
              <a:defRPr sz="10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217129" y="3159765"/>
            <a:ext cx="15739110" cy="15595600"/>
          </a:xfrm>
        </p:spPr>
        <p:txBody>
          <a:bodyPr/>
          <a:lstStyle>
            <a:lvl1pPr>
              <a:defRPr sz="10240"/>
            </a:lvl1pPr>
            <a:lvl2pPr>
              <a:defRPr sz="8960"/>
            </a:lvl2pPr>
            <a:lvl3pPr>
              <a:defRPr sz="768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41460" y="6583680"/>
            <a:ext cx="10027205" cy="12197082"/>
          </a:xfrm>
        </p:spPr>
        <p:txBody>
          <a:bodyPr/>
          <a:lstStyle>
            <a:lvl1pPr marL="0" indent="0">
              <a:buNone/>
              <a:defRPr sz="5120"/>
            </a:lvl1pPr>
            <a:lvl2pPr marL="1463040" indent="0">
              <a:buNone/>
              <a:defRPr sz="4480"/>
            </a:lvl2pPr>
            <a:lvl3pPr marL="2926080" indent="0">
              <a:buNone/>
              <a:defRPr sz="3840"/>
            </a:lvl3pPr>
            <a:lvl4pPr marL="4389120" indent="0">
              <a:buNone/>
              <a:defRPr sz="3200"/>
            </a:lvl4pPr>
            <a:lvl5pPr marL="5852160" indent="0">
              <a:buNone/>
              <a:defRPr sz="3200"/>
            </a:lvl5pPr>
            <a:lvl6pPr marL="7315200" indent="0">
              <a:buNone/>
              <a:defRPr sz="3200"/>
            </a:lvl6pPr>
            <a:lvl7pPr marL="8778240" indent="0">
              <a:buNone/>
              <a:defRPr sz="3200"/>
            </a:lvl7pPr>
            <a:lvl8pPr marL="10241280" indent="0">
              <a:buNone/>
              <a:defRPr sz="3200"/>
            </a:lvl8pPr>
            <a:lvl9pPr marL="11704320" indent="0">
              <a:buNone/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246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460" y="1463040"/>
            <a:ext cx="10027205" cy="5120640"/>
          </a:xfrm>
        </p:spPr>
        <p:txBody>
          <a:bodyPr anchor="b"/>
          <a:lstStyle>
            <a:lvl1pPr>
              <a:defRPr sz="10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217129" y="3159765"/>
            <a:ext cx="15739110" cy="15595600"/>
          </a:xfrm>
        </p:spPr>
        <p:txBody>
          <a:bodyPr anchor="t"/>
          <a:lstStyle>
            <a:lvl1pPr marL="0" indent="0">
              <a:buNone/>
              <a:defRPr sz="10240"/>
            </a:lvl1pPr>
            <a:lvl2pPr marL="1463040" indent="0">
              <a:buNone/>
              <a:defRPr sz="8960"/>
            </a:lvl2pPr>
            <a:lvl3pPr marL="2926080" indent="0">
              <a:buNone/>
              <a:defRPr sz="7680"/>
            </a:lvl3pPr>
            <a:lvl4pPr marL="4389120" indent="0">
              <a:buNone/>
              <a:defRPr sz="6400"/>
            </a:lvl4pPr>
            <a:lvl5pPr marL="5852160" indent="0">
              <a:buNone/>
              <a:defRPr sz="6400"/>
            </a:lvl5pPr>
            <a:lvl6pPr marL="7315200" indent="0">
              <a:buNone/>
              <a:defRPr sz="6400"/>
            </a:lvl6pPr>
            <a:lvl7pPr marL="8778240" indent="0">
              <a:buNone/>
              <a:defRPr sz="6400"/>
            </a:lvl7pPr>
            <a:lvl8pPr marL="10241280" indent="0">
              <a:buNone/>
              <a:defRPr sz="6400"/>
            </a:lvl8pPr>
            <a:lvl9pPr marL="11704320" indent="0">
              <a:buNone/>
              <a:defRPr sz="6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41460" y="6583680"/>
            <a:ext cx="10027205" cy="12197082"/>
          </a:xfrm>
        </p:spPr>
        <p:txBody>
          <a:bodyPr/>
          <a:lstStyle>
            <a:lvl1pPr marL="0" indent="0">
              <a:buNone/>
              <a:defRPr sz="5120"/>
            </a:lvl1pPr>
            <a:lvl2pPr marL="1463040" indent="0">
              <a:buNone/>
              <a:defRPr sz="4480"/>
            </a:lvl2pPr>
            <a:lvl3pPr marL="2926080" indent="0">
              <a:buNone/>
              <a:defRPr sz="3840"/>
            </a:lvl3pPr>
            <a:lvl4pPr marL="4389120" indent="0">
              <a:buNone/>
              <a:defRPr sz="3200"/>
            </a:lvl4pPr>
            <a:lvl5pPr marL="5852160" indent="0">
              <a:buNone/>
              <a:defRPr sz="3200"/>
            </a:lvl5pPr>
            <a:lvl6pPr marL="7315200" indent="0">
              <a:buNone/>
              <a:defRPr sz="3200"/>
            </a:lvl6pPr>
            <a:lvl7pPr marL="8778240" indent="0">
              <a:buNone/>
              <a:defRPr sz="3200"/>
            </a:lvl7pPr>
            <a:lvl8pPr marL="10241280" indent="0">
              <a:buNone/>
              <a:defRPr sz="3200"/>
            </a:lvl8pPr>
            <a:lvl9pPr marL="11704320" indent="0">
              <a:buNone/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74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37410" y="1168405"/>
            <a:ext cx="26814780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37410" y="5842000"/>
            <a:ext cx="26814780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37410" y="20340325"/>
            <a:ext cx="699516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42BFE0-8549-4C1F-84C9-7EF9AF1AAFCF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298430" y="20340325"/>
            <a:ext cx="1049274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957030" y="20340325"/>
            <a:ext cx="699516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566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2926080" rtl="0" eaLnBrk="1" latinLnBrk="0" hangingPunct="1">
        <a:lnSpc>
          <a:spcPct val="90000"/>
        </a:lnSpc>
        <a:spcBef>
          <a:spcPct val="0"/>
        </a:spcBef>
        <a:buNone/>
        <a:defRPr sz="14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31520" indent="-731520" algn="l" defTabSz="2926080" rtl="0" eaLnBrk="1" latinLnBrk="0" hangingPunct="1">
        <a:lnSpc>
          <a:spcPct val="90000"/>
        </a:lnSpc>
        <a:spcBef>
          <a:spcPts val="3200"/>
        </a:spcBef>
        <a:buFont typeface="Arial" panose="020B0604020202020204" pitchFamily="34" charset="0"/>
        <a:buChar char="•"/>
        <a:defRPr sz="8960" kern="1200">
          <a:solidFill>
            <a:schemeClr val="tx1"/>
          </a:solidFill>
          <a:latin typeface="+mn-lt"/>
          <a:ea typeface="+mn-ea"/>
          <a:cs typeface="+mn-cs"/>
        </a:defRPr>
      </a:lvl1pPr>
      <a:lvl2pPr marL="219456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768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6400" kern="1200">
          <a:solidFill>
            <a:schemeClr val="tx1"/>
          </a:solidFill>
          <a:latin typeface="+mn-lt"/>
          <a:ea typeface="+mn-ea"/>
          <a:cs typeface="+mn-cs"/>
        </a:defRPr>
      </a:lvl3pPr>
      <a:lvl4pPr marL="512064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4pPr>
      <a:lvl5pPr marL="658368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5pPr>
      <a:lvl6pPr marL="804672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6pPr>
      <a:lvl7pPr marL="950976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7pPr>
      <a:lvl8pPr marL="1097280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8pPr>
      <a:lvl9pPr marL="1243584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1pPr>
      <a:lvl2pPr marL="146304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2pPr>
      <a:lvl3pPr marL="292608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3pPr>
      <a:lvl4pPr marL="438912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4pPr>
      <a:lvl5pPr marL="585216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5pPr>
      <a:lvl6pPr marL="731520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6pPr>
      <a:lvl7pPr marL="877824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7pPr>
      <a:lvl8pPr marL="1024128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8pPr>
      <a:lvl9pPr marL="1170432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Box 65">
            <a:extLst>
              <a:ext uri="{FF2B5EF4-FFF2-40B4-BE49-F238E27FC236}">
                <a16:creationId xmlns:a16="http://schemas.microsoft.com/office/drawing/2014/main" id="{5AAAC11A-659B-3671-CFFF-C9D35B46DA64}"/>
              </a:ext>
            </a:extLst>
          </p:cNvPr>
          <p:cNvSpPr txBox="1"/>
          <p:nvPr/>
        </p:nvSpPr>
        <p:spPr>
          <a:xfrm>
            <a:off x="2679670" y="6035179"/>
            <a:ext cx="2286000" cy="2286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 w="952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endParaRPr lang="en-US" sz="5400" dirty="0">
              <a:solidFill>
                <a:schemeClr val="bg1"/>
              </a:solidFill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C1FBD85-CFA7-C649-7D5F-F9637CC88127}"/>
              </a:ext>
            </a:extLst>
          </p:cNvPr>
          <p:cNvSpPr txBox="1"/>
          <p:nvPr/>
        </p:nvSpPr>
        <p:spPr>
          <a:xfrm>
            <a:off x="2544005" y="6485682"/>
            <a:ext cx="255733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400" dirty="0">
                <a:solidFill>
                  <a:schemeClr val="bg1"/>
                </a:solidFill>
              </a:rPr>
              <a:t>NTPs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7112613-B5D7-D608-9346-B5DD55E2FDEF}"/>
              </a:ext>
            </a:extLst>
          </p:cNvPr>
          <p:cNvSpPr txBox="1"/>
          <p:nvPr/>
        </p:nvSpPr>
        <p:spPr>
          <a:xfrm>
            <a:off x="5018768" y="7992205"/>
            <a:ext cx="2286000" cy="2286000"/>
          </a:xfrm>
          <a:prstGeom prst="ellipse">
            <a:avLst/>
          </a:prstGeom>
          <a:solidFill>
            <a:schemeClr val="accent6">
              <a:lumMod val="75000"/>
            </a:schemeClr>
          </a:solidFill>
          <a:ln w="952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endParaRPr lang="en-US" sz="5400" dirty="0">
              <a:solidFill>
                <a:schemeClr val="bg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B4F6BBC6-391E-8148-C73A-9671E02C55EC}"/>
              </a:ext>
            </a:extLst>
          </p:cNvPr>
          <p:cNvSpPr txBox="1"/>
          <p:nvPr/>
        </p:nvSpPr>
        <p:spPr>
          <a:xfrm>
            <a:off x="4957849" y="8435498"/>
            <a:ext cx="240783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dirty="0">
                <a:solidFill>
                  <a:schemeClr val="bg1"/>
                </a:solidFill>
              </a:rPr>
              <a:t>GTP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68C4975-6364-F750-7F48-8254DE6A378A}"/>
              </a:ext>
            </a:extLst>
          </p:cNvPr>
          <p:cNvSpPr txBox="1"/>
          <p:nvPr/>
        </p:nvSpPr>
        <p:spPr>
          <a:xfrm>
            <a:off x="6519378" y="5235269"/>
            <a:ext cx="2286000" cy="2286000"/>
          </a:xfrm>
          <a:prstGeom prst="ellipse">
            <a:avLst/>
          </a:prstGeom>
          <a:solidFill>
            <a:schemeClr val="accent4">
              <a:lumMod val="75000"/>
            </a:schemeClr>
          </a:solidFill>
          <a:ln w="952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endParaRPr lang="en-US" sz="5400" dirty="0">
              <a:solidFill>
                <a:schemeClr val="bg1"/>
              </a:solidFill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F26C965-8D15-05BC-272C-04F940FC8481}"/>
              </a:ext>
            </a:extLst>
          </p:cNvPr>
          <p:cNvSpPr txBox="1"/>
          <p:nvPr/>
        </p:nvSpPr>
        <p:spPr>
          <a:xfrm>
            <a:off x="6458458" y="5573156"/>
            <a:ext cx="240783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dirty="0">
                <a:solidFill>
                  <a:schemeClr val="bg1"/>
                </a:solidFill>
              </a:rPr>
              <a:t>ATP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F5D374B0-F16A-3F49-1273-CF7576F8C67F}"/>
              </a:ext>
            </a:extLst>
          </p:cNvPr>
          <p:cNvGrpSpPr/>
          <p:nvPr/>
        </p:nvGrpSpPr>
        <p:grpSpPr>
          <a:xfrm>
            <a:off x="13940087" y="13100742"/>
            <a:ext cx="7203558" cy="8954111"/>
            <a:chOff x="-411955" y="8729375"/>
            <a:chExt cx="7871697" cy="11014684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C311B74E-222A-C365-E73D-C0FCF5A184EB}"/>
                </a:ext>
              </a:extLst>
            </p:cNvPr>
            <p:cNvGrpSpPr/>
            <p:nvPr/>
          </p:nvGrpSpPr>
          <p:grpSpPr>
            <a:xfrm>
              <a:off x="1757272" y="8729375"/>
              <a:ext cx="3036903" cy="7634415"/>
              <a:chOff x="9341364" y="2891367"/>
              <a:chExt cx="3036903" cy="7634415"/>
            </a:xfrm>
          </p:grpSpPr>
          <p:sp>
            <p:nvSpPr>
              <p:cNvPr id="30" name="Oval 29">
                <a:extLst>
                  <a:ext uri="{FF2B5EF4-FFF2-40B4-BE49-F238E27FC236}">
                    <a16:creationId xmlns:a16="http://schemas.microsoft.com/office/drawing/2014/main" id="{D0096BD6-3C5E-200E-29E8-C444A07EE80C}"/>
                  </a:ext>
                </a:extLst>
              </p:cNvPr>
              <p:cNvSpPr/>
              <p:nvPr/>
            </p:nvSpPr>
            <p:spPr>
              <a:xfrm>
                <a:off x="10876112" y="9655176"/>
                <a:ext cx="373655" cy="764859"/>
              </a:xfrm>
              <a:prstGeom prst="ellipse">
                <a:avLst/>
              </a:prstGeom>
              <a:solidFill>
                <a:srgbClr val="F9EFD0"/>
              </a:solidFill>
              <a:ln w="57150">
                <a:solidFill>
                  <a:srgbClr val="F9EFD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003F2DC6-69FD-2B79-EC45-1E03413413F0}"/>
                  </a:ext>
                </a:extLst>
              </p:cNvPr>
              <p:cNvGrpSpPr/>
              <p:nvPr/>
            </p:nvGrpSpPr>
            <p:grpSpPr>
              <a:xfrm>
                <a:off x="9341364" y="2891367"/>
                <a:ext cx="3036903" cy="7634415"/>
                <a:chOff x="10204964" y="2637367"/>
                <a:chExt cx="3036903" cy="7634415"/>
              </a:xfrm>
            </p:grpSpPr>
            <p:sp>
              <p:nvSpPr>
                <p:cNvPr id="34" name="Oval 33">
                  <a:extLst>
                    <a:ext uri="{FF2B5EF4-FFF2-40B4-BE49-F238E27FC236}">
                      <a16:creationId xmlns:a16="http://schemas.microsoft.com/office/drawing/2014/main" id="{760C7707-2309-F6BE-4CB2-FCA2F23717D6}"/>
                    </a:ext>
                  </a:extLst>
                </p:cNvPr>
                <p:cNvSpPr/>
                <p:nvPr/>
              </p:nvSpPr>
              <p:spPr>
                <a:xfrm>
                  <a:off x="11612886" y="9401176"/>
                  <a:ext cx="634677" cy="870606"/>
                </a:xfrm>
                <a:prstGeom prst="ellipse">
                  <a:avLst/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67490CAC-DB95-F0DC-4EEF-0E5556BB2095}"/>
                    </a:ext>
                  </a:extLst>
                </p:cNvPr>
                <p:cNvSpPr/>
                <p:nvPr/>
              </p:nvSpPr>
              <p:spPr>
                <a:xfrm>
                  <a:off x="10898271" y="4668519"/>
                  <a:ext cx="2050649" cy="235163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6" name="Block Arc 35">
                  <a:extLst>
                    <a:ext uri="{FF2B5EF4-FFF2-40B4-BE49-F238E27FC236}">
                      <a16:creationId xmlns:a16="http://schemas.microsoft.com/office/drawing/2014/main" id="{FA7A9429-474A-1C5B-C968-D3E5E4EE4E18}"/>
                    </a:ext>
                  </a:extLst>
                </p:cNvPr>
                <p:cNvSpPr/>
                <p:nvPr/>
              </p:nvSpPr>
              <p:spPr>
                <a:xfrm rot="14698403">
                  <a:off x="10270097" y="2676360"/>
                  <a:ext cx="427356" cy="514795"/>
                </a:xfrm>
                <a:prstGeom prst="blockArc">
                  <a:avLst>
                    <a:gd name="adj1" fmla="val 13560443"/>
                    <a:gd name="adj2" fmla="val 2935971"/>
                    <a:gd name="adj3" fmla="val 24413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7" name="Rectangle 36">
                  <a:extLst>
                    <a:ext uri="{FF2B5EF4-FFF2-40B4-BE49-F238E27FC236}">
                      <a16:creationId xmlns:a16="http://schemas.microsoft.com/office/drawing/2014/main" id="{913C4756-3A88-687D-F0CD-A0252ED26DC1}"/>
                    </a:ext>
                  </a:extLst>
                </p:cNvPr>
                <p:cNvSpPr/>
                <p:nvPr/>
              </p:nvSpPr>
              <p:spPr>
                <a:xfrm>
                  <a:off x="10445751" y="3054350"/>
                  <a:ext cx="464594" cy="10027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8" name="Block Arc 37">
                  <a:extLst>
                    <a:ext uri="{FF2B5EF4-FFF2-40B4-BE49-F238E27FC236}">
                      <a16:creationId xmlns:a16="http://schemas.microsoft.com/office/drawing/2014/main" id="{F35AD1FB-D695-F2BD-663D-088BBA005EB5}"/>
                    </a:ext>
                  </a:extLst>
                </p:cNvPr>
                <p:cNvSpPr/>
                <p:nvPr/>
              </p:nvSpPr>
              <p:spPr>
                <a:xfrm rot="11312380">
                  <a:off x="10247864" y="2641240"/>
                  <a:ext cx="427356" cy="514795"/>
                </a:xfrm>
                <a:prstGeom prst="blockArc">
                  <a:avLst>
                    <a:gd name="adj1" fmla="val 15619198"/>
                    <a:gd name="adj2" fmla="val 16406583"/>
                    <a:gd name="adj3" fmla="val 22545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9" name="Block Arc 38">
                  <a:extLst>
                    <a:ext uri="{FF2B5EF4-FFF2-40B4-BE49-F238E27FC236}">
                      <a16:creationId xmlns:a16="http://schemas.microsoft.com/office/drawing/2014/main" id="{3C4C20A7-0A79-59E0-8E13-221B08ADBB09}"/>
                    </a:ext>
                  </a:extLst>
                </p:cNvPr>
                <p:cNvSpPr/>
                <p:nvPr/>
              </p:nvSpPr>
              <p:spPr>
                <a:xfrm rot="11312380">
                  <a:off x="10204964" y="2933117"/>
                  <a:ext cx="427356" cy="192024"/>
                </a:xfrm>
                <a:prstGeom prst="blockArc">
                  <a:avLst>
                    <a:gd name="adj1" fmla="val 15879138"/>
                    <a:gd name="adj2" fmla="val 17412361"/>
                    <a:gd name="adj3" fmla="val 26734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0" name="Block Arc 39">
                  <a:extLst>
                    <a:ext uri="{FF2B5EF4-FFF2-40B4-BE49-F238E27FC236}">
                      <a16:creationId xmlns:a16="http://schemas.microsoft.com/office/drawing/2014/main" id="{95B816D0-60F1-822F-5694-4250F8112340}"/>
                    </a:ext>
                  </a:extLst>
                </p:cNvPr>
                <p:cNvSpPr/>
                <p:nvPr/>
              </p:nvSpPr>
              <p:spPr>
                <a:xfrm rot="11312380">
                  <a:off x="10214444" y="2933116"/>
                  <a:ext cx="427356" cy="192024"/>
                </a:xfrm>
                <a:prstGeom prst="blockArc">
                  <a:avLst>
                    <a:gd name="adj1" fmla="val 13519529"/>
                    <a:gd name="adj2" fmla="val 16615939"/>
                    <a:gd name="adj3" fmla="val 25588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1" name="Block Arc 40">
                  <a:extLst>
                    <a:ext uri="{FF2B5EF4-FFF2-40B4-BE49-F238E27FC236}">
                      <a16:creationId xmlns:a16="http://schemas.microsoft.com/office/drawing/2014/main" id="{35B97943-5056-1B96-76E8-613E94773EA1}"/>
                    </a:ext>
                  </a:extLst>
                </p:cNvPr>
                <p:cNvSpPr/>
                <p:nvPr/>
              </p:nvSpPr>
              <p:spPr>
                <a:xfrm rot="11032256">
                  <a:off x="10238792" y="2931528"/>
                  <a:ext cx="427356" cy="192024"/>
                </a:xfrm>
                <a:prstGeom prst="blockArc">
                  <a:avLst>
                    <a:gd name="adj1" fmla="val 13519529"/>
                    <a:gd name="adj2" fmla="val 15470025"/>
                    <a:gd name="adj3" fmla="val 23131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2" name="Rectangle: Rounded Corners 41">
                  <a:extLst>
                    <a:ext uri="{FF2B5EF4-FFF2-40B4-BE49-F238E27FC236}">
                      <a16:creationId xmlns:a16="http://schemas.microsoft.com/office/drawing/2014/main" id="{600715B5-58DA-DEB3-15C8-18216706D122}"/>
                    </a:ext>
                  </a:extLst>
                </p:cNvPr>
                <p:cNvSpPr/>
                <p:nvPr/>
              </p:nvSpPr>
              <p:spPr>
                <a:xfrm>
                  <a:off x="10795109" y="2870200"/>
                  <a:ext cx="2235084" cy="358703"/>
                </a:xfrm>
                <a:prstGeom prst="roundRect">
                  <a:avLst>
                    <a:gd name="adj" fmla="val 30607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3" name="Rectangle: Rounded Corners 42">
                  <a:extLst>
                    <a:ext uri="{FF2B5EF4-FFF2-40B4-BE49-F238E27FC236}">
                      <a16:creationId xmlns:a16="http://schemas.microsoft.com/office/drawing/2014/main" id="{98176D74-C764-F351-BB55-CCE45EC05478}"/>
                    </a:ext>
                  </a:extLst>
                </p:cNvPr>
                <p:cNvSpPr/>
                <p:nvPr/>
              </p:nvSpPr>
              <p:spPr>
                <a:xfrm>
                  <a:off x="10565822" y="2637367"/>
                  <a:ext cx="2676045" cy="326453"/>
                </a:xfrm>
                <a:prstGeom prst="roundRect">
                  <a:avLst>
                    <a:gd name="adj" fmla="val 41305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Trapezoid 43">
                  <a:extLst>
                    <a:ext uri="{FF2B5EF4-FFF2-40B4-BE49-F238E27FC236}">
                      <a16:creationId xmlns:a16="http://schemas.microsoft.com/office/drawing/2014/main" id="{FFB2A9FB-9E18-8191-4236-3BCC0353D880}"/>
                    </a:ext>
                  </a:extLst>
                </p:cNvPr>
                <p:cNvSpPr/>
                <p:nvPr/>
              </p:nvSpPr>
              <p:spPr>
                <a:xfrm rot="10800000">
                  <a:off x="10894226" y="7020147"/>
                  <a:ext cx="2071313" cy="2957101"/>
                </a:xfrm>
                <a:prstGeom prst="trapezoid">
                  <a:avLst>
                    <a:gd name="adj" fmla="val 36875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66BC3655-2FBF-DD3E-46D2-54A1498186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227809" y="7020153"/>
                  <a:ext cx="726191" cy="2989638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5AF93083-5F33-D67B-4930-892189C2337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7020153"/>
                  <a:ext cx="744971" cy="2996972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042CBCAF-C9E8-AE99-C458-502FC2564A26}"/>
                    </a:ext>
                  </a:extLst>
                </p:cNvPr>
                <p:cNvSpPr/>
                <p:nvPr/>
              </p:nvSpPr>
              <p:spPr>
                <a:xfrm>
                  <a:off x="10898271" y="3262086"/>
                  <a:ext cx="2050649" cy="1538229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584D2B5C-1176-EB4A-F259-D3E14CBA8014}"/>
                    </a:ext>
                  </a:extLst>
                </p:cNvPr>
                <p:cNvSpPr/>
                <p:nvPr/>
              </p:nvSpPr>
              <p:spPr>
                <a:xfrm>
                  <a:off x="11012077" y="4677907"/>
                  <a:ext cx="1827973" cy="2351633"/>
                </a:xfrm>
                <a:prstGeom prst="rect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49" name="Straight Connector 48">
                  <a:extLst>
                    <a:ext uri="{FF2B5EF4-FFF2-40B4-BE49-F238E27FC236}">
                      <a16:creationId xmlns:a16="http://schemas.microsoft.com/office/drawing/2014/main" id="{B3D461EE-C007-8D7C-ED5D-EE9B164983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530352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Connector 49">
                  <a:extLst>
                    <a:ext uri="{FF2B5EF4-FFF2-40B4-BE49-F238E27FC236}">
                      <a16:creationId xmlns:a16="http://schemas.microsoft.com/office/drawing/2014/main" id="{F18DE077-1B4E-4C71-829D-9591E2F620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75046" y="685800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1" name="Oval 50">
                  <a:extLst>
                    <a:ext uri="{FF2B5EF4-FFF2-40B4-BE49-F238E27FC236}">
                      <a16:creationId xmlns:a16="http://schemas.microsoft.com/office/drawing/2014/main" id="{64788829-3052-6DFA-9A28-5DC7122E4B1A}"/>
                    </a:ext>
                  </a:extLst>
                </p:cNvPr>
                <p:cNvSpPr/>
                <p:nvPr/>
              </p:nvSpPr>
              <p:spPr>
                <a:xfrm>
                  <a:off x="11739712" y="9419272"/>
                  <a:ext cx="373655" cy="764859"/>
                </a:xfrm>
                <a:prstGeom prst="ellipse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2" name="Straight Connector 51">
                  <a:extLst>
                    <a:ext uri="{FF2B5EF4-FFF2-40B4-BE49-F238E27FC236}">
                      <a16:creationId xmlns:a16="http://schemas.microsoft.com/office/drawing/2014/main" id="{427BA05C-6B3D-DDA9-42EF-4412C03391D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374396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56ED5A87-DA5E-B771-ED01-9BB00115D3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948920" y="3236263"/>
                  <a:ext cx="0" cy="3808748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744BF48F-6AE6-C447-5172-64061546729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3236263"/>
                  <a:ext cx="0" cy="3801125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5" name="Trapezoid 54">
                  <a:extLst>
                    <a:ext uri="{FF2B5EF4-FFF2-40B4-BE49-F238E27FC236}">
                      <a16:creationId xmlns:a16="http://schemas.microsoft.com/office/drawing/2014/main" id="{BBF0DDDC-2AE8-3929-FD30-536FFD97D682}"/>
                    </a:ext>
                  </a:extLst>
                </p:cNvPr>
                <p:cNvSpPr/>
                <p:nvPr/>
              </p:nvSpPr>
              <p:spPr>
                <a:xfrm rot="10800000">
                  <a:off x="11020539" y="7078403"/>
                  <a:ext cx="1810512" cy="2957103"/>
                </a:xfrm>
                <a:prstGeom prst="trapezoid">
                  <a:avLst>
                    <a:gd name="adj" fmla="val 41887"/>
                  </a:avLst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6" name="Trapezoid 55">
                  <a:extLst>
                    <a:ext uri="{FF2B5EF4-FFF2-40B4-BE49-F238E27FC236}">
                      <a16:creationId xmlns:a16="http://schemas.microsoft.com/office/drawing/2014/main" id="{ABAAF82E-01BA-4408-D5F6-22E26FF0BB26}"/>
                    </a:ext>
                  </a:extLst>
                </p:cNvPr>
                <p:cNvSpPr/>
                <p:nvPr/>
              </p:nvSpPr>
              <p:spPr>
                <a:xfrm rot="10800000">
                  <a:off x="11920875" y="9997666"/>
                  <a:ext cx="126948" cy="73152"/>
                </a:xfrm>
                <a:prstGeom prst="trapezoid">
                  <a:avLst>
                    <a:gd name="adj" fmla="val 3698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7" name="Rectangle: Rounded Corners 56">
                  <a:extLst>
                    <a:ext uri="{FF2B5EF4-FFF2-40B4-BE49-F238E27FC236}">
                      <a16:creationId xmlns:a16="http://schemas.microsoft.com/office/drawing/2014/main" id="{AAA50D52-E2E9-6A86-C3AE-C8DC802EA644}"/>
                    </a:ext>
                  </a:extLst>
                </p:cNvPr>
                <p:cNvSpPr/>
                <p:nvPr/>
              </p:nvSpPr>
              <p:spPr>
                <a:xfrm>
                  <a:off x="11042409" y="6947350"/>
                  <a:ext cx="1768712" cy="195322"/>
                </a:xfrm>
                <a:prstGeom prst="roundRect">
                  <a:avLst>
                    <a:gd name="adj" fmla="val 1961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8" name="Straight Connector 57">
                  <a:extLst>
                    <a:ext uri="{FF2B5EF4-FFF2-40B4-BE49-F238E27FC236}">
                      <a16:creationId xmlns:a16="http://schemas.microsoft.com/office/drawing/2014/main" id="{8D2DA37C-2072-1B6B-1E25-38B9D1CBF4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012077" y="7050469"/>
                  <a:ext cx="49623" cy="182344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39426AFF-4F1C-EE8F-58EC-393960963B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792075" y="7045860"/>
                  <a:ext cx="46451" cy="186953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" name="Trapezoid 31">
                <a:extLst>
                  <a:ext uri="{FF2B5EF4-FFF2-40B4-BE49-F238E27FC236}">
                    <a16:creationId xmlns:a16="http://schemas.microsoft.com/office/drawing/2014/main" id="{CD4A3D61-EBEB-9F94-12D6-ADC8FE72CE56}"/>
                  </a:ext>
                </a:extLst>
              </p:cNvPr>
              <p:cNvSpPr/>
              <p:nvPr/>
            </p:nvSpPr>
            <p:spPr>
              <a:xfrm rot="10800000">
                <a:off x="10942833" y="10253325"/>
                <a:ext cx="126948" cy="73152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3" name="Trapezoid 32">
                <a:extLst>
                  <a:ext uri="{FF2B5EF4-FFF2-40B4-BE49-F238E27FC236}">
                    <a16:creationId xmlns:a16="http://schemas.microsoft.com/office/drawing/2014/main" id="{6A4477BA-A435-BFD7-3C24-10D6637FB7F1}"/>
                  </a:ext>
                </a:extLst>
              </p:cNvPr>
              <p:cNvSpPr/>
              <p:nvPr/>
            </p:nvSpPr>
            <p:spPr>
              <a:xfrm rot="10800000">
                <a:off x="10996688" y="10255028"/>
                <a:ext cx="126949" cy="73152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97EDF93-E169-A18E-AFBB-D4BFE96FD75E}"/>
                </a:ext>
              </a:extLst>
            </p:cNvPr>
            <p:cNvSpPr txBox="1"/>
            <p:nvPr/>
          </p:nvSpPr>
          <p:spPr>
            <a:xfrm>
              <a:off x="-411955" y="16601647"/>
              <a:ext cx="7871697" cy="3142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0" dirty="0"/>
                <a:t>TX-TL reaction mixture</a:t>
              </a:r>
            </a:p>
          </p:txBody>
        </p:sp>
        <p:sp>
          <p:nvSpPr>
            <p:cNvPr id="18" name="Hexagon 17">
              <a:extLst>
                <a:ext uri="{FF2B5EF4-FFF2-40B4-BE49-F238E27FC236}">
                  <a16:creationId xmlns:a16="http://schemas.microsoft.com/office/drawing/2014/main" id="{48A9641C-0871-D05B-E3DD-779CF0E0AAEB}"/>
                </a:ext>
              </a:extLst>
            </p:cNvPr>
            <p:cNvSpPr/>
            <p:nvPr/>
          </p:nvSpPr>
          <p:spPr>
            <a:xfrm>
              <a:off x="2646064" y="11393153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9" name="Hexagon 18">
              <a:extLst>
                <a:ext uri="{FF2B5EF4-FFF2-40B4-BE49-F238E27FC236}">
                  <a16:creationId xmlns:a16="http://schemas.microsoft.com/office/drawing/2014/main" id="{78914CB7-4966-10CD-F6C2-0AE7B912855D}"/>
                </a:ext>
              </a:extLst>
            </p:cNvPr>
            <p:cNvSpPr/>
            <p:nvPr/>
          </p:nvSpPr>
          <p:spPr>
            <a:xfrm>
              <a:off x="3726148" y="1178582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" name="Hexagon 19">
              <a:extLst>
                <a:ext uri="{FF2B5EF4-FFF2-40B4-BE49-F238E27FC236}">
                  <a16:creationId xmlns:a16="http://schemas.microsoft.com/office/drawing/2014/main" id="{09E639EA-0B24-6471-3E6F-E472AC173A12}"/>
                </a:ext>
              </a:extLst>
            </p:cNvPr>
            <p:cNvSpPr/>
            <p:nvPr/>
          </p:nvSpPr>
          <p:spPr>
            <a:xfrm>
              <a:off x="2965781" y="12688178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" name="Hexagon 20">
              <a:extLst>
                <a:ext uri="{FF2B5EF4-FFF2-40B4-BE49-F238E27FC236}">
                  <a16:creationId xmlns:a16="http://schemas.microsoft.com/office/drawing/2014/main" id="{59DEF88C-BFC0-AC19-869A-8B6EF561888C}"/>
                </a:ext>
              </a:extLst>
            </p:cNvPr>
            <p:cNvSpPr/>
            <p:nvPr/>
          </p:nvSpPr>
          <p:spPr>
            <a:xfrm>
              <a:off x="3586448" y="10994577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Hexagon 21">
              <a:extLst>
                <a:ext uri="{FF2B5EF4-FFF2-40B4-BE49-F238E27FC236}">
                  <a16:creationId xmlns:a16="http://schemas.microsoft.com/office/drawing/2014/main" id="{735BEA6A-0C4C-B8CF-E22E-B8A69B4E39D2}"/>
                </a:ext>
              </a:extLst>
            </p:cNvPr>
            <p:cNvSpPr/>
            <p:nvPr/>
          </p:nvSpPr>
          <p:spPr>
            <a:xfrm>
              <a:off x="3654145" y="1385148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9E46A1C2-EB1D-1E9B-B2D4-ADE3A576A2B9}"/>
                </a:ext>
              </a:extLst>
            </p:cNvPr>
            <p:cNvSpPr/>
            <p:nvPr/>
          </p:nvSpPr>
          <p:spPr>
            <a:xfrm>
              <a:off x="3081655" y="1195580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0F9259A8-18A3-5460-1805-24EF1D6B3467}"/>
                </a:ext>
              </a:extLst>
            </p:cNvPr>
            <p:cNvSpPr/>
            <p:nvPr/>
          </p:nvSpPr>
          <p:spPr>
            <a:xfrm>
              <a:off x="3364944" y="1235695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CEE54F55-E71A-0453-CA5C-91A602097784}"/>
                </a:ext>
              </a:extLst>
            </p:cNvPr>
            <p:cNvSpPr/>
            <p:nvPr/>
          </p:nvSpPr>
          <p:spPr>
            <a:xfrm>
              <a:off x="3010530" y="14107849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26" name="Connector: Curved 25">
              <a:extLst>
                <a:ext uri="{FF2B5EF4-FFF2-40B4-BE49-F238E27FC236}">
                  <a16:creationId xmlns:a16="http://schemas.microsoft.com/office/drawing/2014/main" id="{2D0A8BDD-980B-95B2-DFFE-EE2357CA611D}"/>
                </a:ext>
              </a:extLst>
            </p:cNvPr>
            <p:cNvCxnSpPr/>
            <p:nvPr/>
          </p:nvCxnSpPr>
          <p:spPr>
            <a:xfrm rot="10800000" flipV="1">
              <a:off x="3207177" y="13301673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ctor: Curved 26">
              <a:extLst>
                <a:ext uri="{FF2B5EF4-FFF2-40B4-BE49-F238E27FC236}">
                  <a16:creationId xmlns:a16="http://schemas.microsoft.com/office/drawing/2014/main" id="{D9DABCF6-771E-B41D-5CD9-2F34A412F87C}"/>
                </a:ext>
              </a:extLst>
            </p:cNvPr>
            <p:cNvCxnSpPr/>
            <p:nvPr/>
          </p:nvCxnSpPr>
          <p:spPr>
            <a:xfrm rot="10800000" flipV="1">
              <a:off x="2882340" y="11603929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ctor: Curved 27">
              <a:extLst>
                <a:ext uri="{FF2B5EF4-FFF2-40B4-BE49-F238E27FC236}">
                  <a16:creationId xmlns:a16="http://schemas.microsoft.com/office/drawing/2014/main" id="{ADA2BA13-6756-E7F8-9159-F6E3A1C76DDD}"/>
                </a:ext>
              </a:extLst>
            </p:cNvPr>
            <p:cNvCxnSpPr/>
            <p:nvPr/>
          </p:nvCxnSpPr>
          <p:spPr>
            <a:xfrm rot="10800000" flipV="1">
              <a:off x="3263340" y="12886629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or: Curved 28">
              <a:extLst>
                <a:ext uri="{FF2B5EF4-FFF2-40B4-BE49-F238E27FC236}">
                  <a16:creationId xmlns:a16="http://schemas.microsoft.com/office/drawing/2014/main" id="{C54680C7-C357-2048-EE84-26149F762813}"/>
                </a:ext>
              </a:extLst>
            </p:cNvPr>
            <p:cNvCxnSpPr/>
            <p:nvPr/>
          </p:nvCxnSpPr>
          <p:spPr>
            <a:xfrm rot="10800000" flipV="1">
              <a:off x="3359577" y="14503228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" name="TextBox 60">
            <a:extLst>
              <a:ext uri="{FF2B5EF4-FFF2-40B4-BE49-F238E27FC236}">
                <a16:creationId xmlns:a16="http://schemas.microsoft.com/office/drawing/2014/main" id="{C35BACB9-27F0-B0C3-171C-A6F344E56233}"/>
              </a:ext>
            </a:extLst>
          </p:cNvPr>
          <p:cNvSpPr txBox="1"/>
          <p:nvPr/>
        </p:nvSpPr>
        <p:spPr>
          <a:xfrm>
            <a:off x="13630058" y="9059421"/>
            <a:ext cx="7416772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dirty="0"/>
              <a:t>Echo 525 Liquid Handler</a:t>
            </a: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FBD879E0-2BD7-3D75-373F-C41EE64D28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62101" y="7766327"/>
            <a:ext cx="7599230" cy="5624289"/>
          </a:xfrm>
          <a:prstGeom prst="rect">
            <a:avLst/>
          </a:prstGeom>
        </p:spPr>
      </p:pic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A8EAE74D-59EE-A72E-EB7F-61D16AE3FB45}"/>
              </a:ext>
            </a:extLst>
          </p:cNvPr>
          <p:cNvCxnSpPr>
            <a:cxnSpLocks/>
          </p:cNvCxnSpPr>
          <p:nvPr/>
        </p:nvCxnSpPr>
        <p:spPr>
          <a:xfrm>
            <a:off x="11467311" y="5130646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B3C5809D-7ECA-3B1E-BBC7-BE522A36FEA3}"/>
              </a:ext>
            </a:extLst>
          </p:cNvPr>
          <p:cNvSpPr txBox="1"/>
          <p:nvPr/>
        </p:nvSpPr>
        <p:spPr>
          <a:xfrm>
            <a:off x="23031335" y="13431484"/>
            <a:ext cx="7460762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dirty="0"/>
              <a:t>10µL reactions in 384-well plate</a:t>
            </a: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2B5313FB-72C3-22E7-2A7B-A252BEEFC6FC}"/>
              </a:ext>
            </a:extLst>
          </p:cNvPr>
          <p:cNvCxnSpPr/>
          <p:nvPr/>
        </p:nvCxnSpPr>
        <p:spPr>
          <a:xfrm>
            <a:off x="3879876" y="19595930"/>
            <a:ext cx="4114800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0E062A12-742F-323E-199C-012FD6D5A1A5}"/>
              </a:ext>
            </a:extLst>
          </p:cNvPr>
          <p:cNvCxnSpPr>
            <a:cxnSpLocks/>
          </p:cNvCxnSpPr>
          <p:nvPr/>
        </p:nvCxnSpPr>
        <p:spPr>
          <a:xfrm flipV="1">
            <a:off x="3919525" y="18452456"/>
            <a:ext cx="2286000" cy="114300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8B2D73B0-C9BA-0150-D173-A3E8858D8537}"/>
              </a:ext>
            </a:extLst>
          </p:cNvPr>
          <p:cNvCxnSpPr>
            <a:cxnSpLocks/>
          </p:cNvCxnSpPr>
          <p:nvPr/>
        </p:nvCxnSpPr>
        <p:spPr>
          <a:xfrm flipV="1">
            <a:off x="3900082" y="15520398"/>
            <a:ext cx="0" cy="411480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D045C290-7853-948D-BE39-9959C1CE23E1}"/>
              </a:ext>
            </a:extLst>
          </p:cNvPr>
          <p:cNvSpPr txBox="1"/>
          <p:nvPr/>
        </p:nvSpPr>
        <p:spPr>
          <a:xfrm>
            <a:off x="6330908" y="19720182"/>
            <a:ext cx="55526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dirty="0"/>
              <a:t>[Added GTP]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7D8919F-EA14-4110-1FE8-7976CD03F7E5}"/>
              </a:ext>
            </a:extLst>
          </p:cNvPr>
          <p:cNvSpPr txBox="1"/>
          <p:nvPr/>
        </p:nvSpPr>
        <p:spPr>
          <a:xfrm>
            <a:off x="4822664" y="17093771"/>
            <a:ext cx="594204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dirty="0"/>
              <a:t>[Added ATP]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682156B-1481-3147-F84E-2D03D80FEB4C}"/>
              </a:ext>
            </a:extLst>
          </p:cNvPr>
          <p:cNvSpPr txBox="1"/>
          <p:nvPr/>
        </p:nvSpPr>
        <p:spPr>
          <a:xfrm>
            <a:off x="1015129" y="14569955"/>
            <a:ext cx="302527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0" dirty="0"/>
              <a:t>[NTPs]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C7F8FD8-7A83-2BE6-310B-25F489528D9F}"/>
              </a:ext>
            </a:extLst>
          </p:cNvPr>
          <p:cNvGrpSpPr/>
          <p:nvPr/>
        </p:nvGrpSpPr>
        <p:grpSpPr>
          <a:xfrm>
            <a:off x="621114" y="212176"/>
            <a:ext cx="10293631" cy="4474460"/>
            <a:chOff x="489316" y="12776887"/>
            <a:chExt cx="10293631" cy="447446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3B59C4E-569F-66FD-4B3D-53D26430A6D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95969" y="14032207"/>
              <a:ext cx="1640904" cy="1647403"/>
            </a:xfrm>
            <a:prstGeom prst="rect">
              <a:avLst/>
            </a:prstGeom>
          </p:spPr>
        </p:pic>
        <p:sp>
          <p:nvSpPr>
            <p:cNvPr id="4" name="Rectangle: Rounded Corners 3">
              <a:extLst>
                <a:ext uri="{FF2B5EF4-FFF2-40B4-BE49-F238E27FC236}">
                  <a16:creationId xmlns:a16="http://schemas.microsoft.com/office/drawing/2014/main" id="{0857458E-BDC5-98EB-3A3B-6863FF255B04}"/>
                </a:ext>
              </a:extLst>
            </p:cNvPr>
            <p:cNvSpPr/>
            <p:nvPr/>
          </p:nvSpPr>
          <p:spPr>
            <a:xfrm>
              <a:off x="489316" y="15707157"/>
              <a:ext cx="10293631" cy="1544190"/>
            </a:xfrm>
            <a:prstGeom prst="roundRect">
              <a:avLst/>
            </a:prstGeom>
            <a:noFill/>
            <a:ln w="1143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6771081B-9DF3-C5BB-60D6-41B07FE88351}"/>
                </a:ext>
              </a:extLst>
            </p:cNvPr>
            <p:cNvCxnSpPr/>
            <p:nvPr/>
          </p:nvCxnSpPr>
          <p:spPr>
            <a:xfrm>
              <a:off x="1154301" y="14294282"/>
              <a:ext cx="0" cy="146304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94DA38A6-91C3-30B7-C3FC-33AA1A7981E9}"/>
                </a:ext>
              </a:extLst>
            </p:cNvPr>
            <p:cNvCxnSpPr>
              <a:cxnSpLocks/>
            </p:cNvCxnSpPr>
            <p:nvPr/>
          </p:nvCxnSpPr>
          <p:spPr>
            <a:xfrm>
              <a:off x="1190615" y="14347622"/>
              <a:ext cx="1043360" cy="0"/>
            </a:xfrm>
            <a:prstGeom prst="line">
              <a:avLst/>
            </a:prstGeom>
            <a:ln w="1143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Partial Circle 6">
              <a:extLst>
                <a:ext uri="{FF2B5EF4-FFF2-40B4-BE49-F238E27FC236}">
                  <a16:creationId xmlns:a16="http://schemas.microsoft.com/office/drawing/2014/main" id="{C2327BE6-0F08-A384-A14A-90426D681E1A}"/>
                </a:ext>
              </a:extLst>
            </p:cNvPr>
            <p:cNvSpPr/>
            <p:nvPr/>
          </p:nvSpPr>
          <p:spPr>
            <a:xfrm rot="5400000">
              <a:off x="4085125" y="15265521"/>
              <a:ext cx="1035047" cy="883279"/>
            </a:xfrm>
            <a:prstGeom prst="pie">
              <a:avLst>
                <a:gd name="adj1" fmla="val 5418294"/>
                <a:gd name="adj2" fmla="val 16200000"/>
              </a:avLst>
            </a:prstGeom>
            <a:noFill/>
            <a:ln w="1143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DEE8E45-F24C-ED75-9E96-7B2DFAF99D6E}"/>
                </a:ext>
              </a:extLst>
            </p:cNvPr>
            <p:cNvSpPr txBox="1"/>
            <p:nvPr/>
          </p:nvSpPr>
          <p:spPr>
            <a:xfrm>
              <a:off x="5643928" y="15106995"/>
              <a:ext cx="3698875" cy="1323439"/>
            </a:xfrm>
            <a:prstGeom prst="homePlate">
              <a:avLst/>
            </a:prstGeom>
            <a:solidFill>
              <a:srgbClr val="70AD47"/>
            </a:solidFill>
            <a:ln w="762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0" b="1" i="1" dirty="0"/>
                <a:t>deGFP</a:t>
              </a: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3539AFA9-023A-813B-D1F8-132D6133F9C6}"/>
                </a:ext>
              </a:extLst>
            </p:cNvPr>
            <p:cNvCxnSpPr/>
            <p:nvPr/>
          </p:nvCxnSpPr>
          <p:spPr>
            <a:xfrm>
              <a:off x="9885096" y="14666863"/>
              <a:ext cx="0" cy="100584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A46D9317-8C40-DD3A-446D-5D1AE6A50764}"/>
                </a:ext>
              </a:extLst>
            </p:cNvPr>
            <p:cNvCxnSpPr>
              <a:cxnSpLocks/>
            </p:cNvCxnSpPr>
            <p:nvPr/>
          </p:nvCxnSpPr>
          <p:spPr>
            <a:xfrm>
              <a:off x="9342803" y="14677464"/>
              <a:ext cx="1028701" cy="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B23E93D-9854-514A-28E9-79DDDDE1EA1C}"/>
                </a:ext>
              </a:extLst>
            </p:cNvPr>
            <p:cNvSpPr txBox="1"/>
            <p:nvPr/>
          </p:nvSpPr>
          <p:spPr>
            <a:xfrm>
              <a:off x="2203199" y="12776887"/>
              <a:ext cx="1802897" cy="1323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0" b="1" dirty="0"/>
                <a:t>MG</a:t>
              </a:r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E139FD01-7D7A-B62C-5068-30DE21BFE0F6}"/>
                </a:ext>
              </a:extLst>
            </p:cNvPr>
            <p:cNvSpPr/>
            <p:nvPr/>
          </p:nvSpPr>
          <p:spPr>
            <a:xfrm>
              <a:off x="3965742" y="13157719"/>
              <a:ext cx="548640" cy="548640"/>
            </a:xfrm>
            <a:prstGeom prst="ellipse">
              <a:avLst/>
            </a:prstGeom>
            <a:solidFill>
              <a:schemeClr val="accent2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7C880E42-7630-9A66-1F5A-3669C5F955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82747" y="150448"/>
            <a:ext cx="5057081" cy="8591688"/>
          </a:xfrm>
          <a:prstGeom prst="rect">
            <a:avLst/>
          </a:prstGeom>
        </p:spPr>
      </p:pic>
      <p:sp>
        <p:nvSpPr>
          <p:cNvPr id="14" name="Arc 13">
            <a:extLst>
              <a:ext uri="{FF2B5EF4-FFF2-40B4-BE49-F238E27FC236}">
                <a16:creationId xmlns:a16="http://schemas.microsoft.com/office/drawing/2014/main" id="{D88545A1-B913-E7CE-61FD-C54847F911E8}"/>
              </a:ext>
            </a:extLst>
          </p:cNvPr>
          <p:cNvSpPr/>
          <p:nvPr/>
        </p:nvSpPr>
        <p:spPr>
          <a:xfrm>
            <a:off x="18466007" y="4340230"/>
            <a:ext cx="5355276" cy="5624289"/>
          </a:xfrm>
          <a:prstGeom prst="arc">
            <a:avLst>
              <a:gd name="adj1" fmla="val 16200000"/>
              <a:gd name="adj2" fmla="val 20740571"/>
            </a:avLst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Arc 78">
            <a:extLst>
              <a:ext uri="{FF2B5EF4-FFF2-40B4-BE49-F238E27FC236}">
                <a16:creationId xmlns:a16="http://schemas.microsoft.com/office/drawing/2014/main" id="{3C9D8C2C-CA97-A16C-A7AE-0DDE3CA69A2F}"/>
              </a:ext>
            </a:extLst>
          </p:cNvPr>
          <p:cNvSpPr/>
          <p:nvPr/>
        </p:nvSpPr>
        <p:spPr>
          <a:xfrm flipV="1">
            <a:off x="18459520" y="13362878"/>
            <a:ext cx="5355276" cy="5624289"/>
          </a:xfrm>
          <a:prstGeom prst="arc">
            <a:avLst>
              <a:gd name="adj1" fmla="val 16200000"/>
              <a:gd name="adj2" fmla="val 20558681"/>
            </a:avLst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1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5</TotalTime>
  <Words>28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isha Kapasiawala</dc:creator>
  <cp:lastModifiedBy>Manisha Kapasiawala</cp:lastModifiedBy>
  <cp:revision>8</cp:revision>
  <dcterms:created xsi:type="dcterms:W3CDTF">2024-03-11T18:55:17Z</dcterms:created>
  <dcterms:modified xsi:type="dcterms:W3CDTF">2024-03-27T17:39:24Z</dcterms:modified>
</cp:coreProperties>
</file>